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60" r:id="rId2"/>
    <p:sldId id="259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9" autoAdjust="0"/>
    <p:restoredTop sz="94660"/>
  </p:normalViewPr>
  <p:slideViewPr>
    <p:cSldViewPr snapToGrid="0">
      <p:cViewPr>
        <p:scale>
          <a:sx n="150" d="100"/>
          <a:sy n="150" d="100"/>
        </p:scale>
        <p:origin x="574" y="-2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luís Camprubí Ferrer" userId="c12eb02d-37fe-4c81-83cb-5a4938498196" providerId="ADAL" clId="{7A4DC3D5-6D1A-4182-AC93-A8B7729B0220}"/>
    <pc:docChg chg="modSld">
      <pc:chgData name="Lluís Camprubí Ferrer" userId="c12eb02d-37fe-4c81-83cb-5a4938498196" providerId="ADAL" clId="{7A4DC3D5-6D1A-4182-AC93-A8B7729B0220}" dt="2025-09-17T15:10:03.158" v="20" actId="1076"/>
      <pc:docMkLst>
        <pc:docMk/>
      </pc:docMkLst>
      <pc:sldChg chg="modSp mod">
        <pc:chgData name="Lluís Camprubí Ferrer" userId="c12eb02d-37fe-4c81-83cb-5a4938498196" providerId="ADAL" clId="{7A4DC3D5-6D1A-4182-AC93-A8B7729B0220}" dt="2025-09-17T15:10:03.158" v="20" actId="1076"/>
        <pc:sldMkLst>
          <pc:docMk/>
          <pc:sldMk cId="1577899297" sldId="259"/>
        </pc:sldMkLst>
        <pc:spChg chg="mod">
          <ac:chgData name="Lluís Camprubí Ferrer" userId="c12eb02d-37fe-4c81-83cb-5a4938498196" providerId="ADAL" clId="{7A4DC3D5-6D1A-4182-AC93-A8B7729B0220}" dt="2025-09-17T15:09:25.508" v="14" actId="1076"/>
          <ac:spMkLst>
            <pc:docMk/>
            <pc:sldMk cId="1577899297" sldId="259"/>
            <ac:spMk id="8" creationId="{977A93EF-14FC-9B98-831E-C999D108C1F8}"/>
          </ac:spMkLst>
        </pc:spChg>
        <pc:spChg chg="mod">
          <ac:chgData name="Lluís Camprubí Ferrer" userId="c12eb02d-37fe-4c81-83cb-5a4938498196" providerId="ADAL" clId="{7A4DC3D5-6D1A-4182-AC93-A8B7729B0220}" dt="2025-09-17T15:10:03.158" v="20" actId="1076"/>
          <ac:spMkLst>
            <pc:docMk/>
            <pc:sldMk cId="1577899297" sldId="259"/>
            <ac:spMk id="11" creationId="{EE4E60E1-D7B6-37EC-0B77-585DE09E8589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S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F2BD767-8EC6-4762-A7A7-B6FF6308B152}" type="datetimeFigureOut">
              <a:rPr lang="en-SE" smtClean="0"/>
              <a:t>2025-09-17</a:t>
            </a:fld>
            <a:endParaRPr lang="en-S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S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D53E12-7498-45E5-985E-2B9DF2703B69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18097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DD53E12-7498-45E5-985E-2B9DF2703B69}" type="slidenum">
              <a:rPr lang="en-SE" smtClean="0"/>
              <a:t>2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1268490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37E18-519D-46E0-89FC-8D2AF5658953}" type="datetimeFigureOut">
              <a:rPr lang="en-SE" smtClean="0"/>
              <a:t>2025-09-17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81081-C203-4E1C-A204-5A6B44C8C6A5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2796366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37E18-519D-46E0-89FC-8D2AF5658953}" type="datetimeFigureOut">
              <a:rPr lang="en-SE" smtClean="0"/>
              <a:t>2025-09-17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81081-C203-4E1C-A204-5A6B44C8C6A5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6860082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37E18-519D-46E0-89FC-8D2AF5658953}" type="datetimeFigureOut">
              <a:rPr lang="en-SE" smtClean="0"/>
              <a:t>2025-09-17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81081-C203-4E1C-A204-5A6B44C8C6A5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6113655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37E18-519D-46E0-89FC-8D2AF5658953}" type="datetimeFigureOut">
              <a:rPr lang="en-SE" smtClean="0"/>
              <a:t>2025-09-17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81081-C203-4E1C-A204-5A6B44C8C6A5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707157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37E18-519D-46E0-89FC-8D2AF5658953}" type="datetimeFigureOut">
              <a:rPr lang="en-SE" smtClean="0"/>
              <a:t>2025-09-17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81081-C203-4E1C-A204-5A6B44C8C6A5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0288905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37E18-519D-46E0-89FC-8D2AF5658953}" type="datetimeFigureOut">
              <a:rPr lang="en-SE" smtClean="0"/>
              <a:t>2025-09-17</a:t>
            </a:fld>
            <a:endParaRPr lang="en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81081-C203-4E1C-A204-5A6B44C8C6A5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168229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37E18-519D-46E0-89FC-8D2AF5658953}" type="datetimeFigureOut">
              <a:rPr lang="en-SE" smtClean="0"/>
              <a:t>2025-09-17</a:t>
            </a:fld>
            <a:endParaRPr lang="en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81081-C203-4E1C-A204-5A6B44C8C6A5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250238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37E18-519D-46E0-89FC-8D2AF5658953}" type="datetimeFigureOut">
              <a:rPr lang="en-SE" smtClean="0"/>
              <a:t>2025-09-17</a:t>
            </a:fld>
            <a:endParaRPr lang="en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81081-C203-4E1C-A204-5A6B44C8C6A5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2179858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37E18-519D-46E0-89FC-8D2AF5658953}" type="datetimeFigureOut">
              <a:rPr lang="en-SE" smtClean="0"/>
              <a:t>2025-09-17</a:t>
            </a:fld>
            <a:endParaRPr lang="en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81081-C203-4E1C-A204-5A6B44C8C6A5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666291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37E18-519D-46E0-89FC-8D2AF5658953}" type="datetimeFigureOut">
              <a:rPr lang="en-SE" smtClean="0"/>
              <a:t>2025-09-17</a:t>
            </a:fld>
            <a:endParaRPr lang="en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81081-C203-4E1C-A204-5A6B44C8C6A5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406233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37E18-519D-46E0-89FC-8D2AF5658953}" type="datetimeFigureOut">
              <a:rPr lang="en-SE" smtClean="0"/>
              <a:t>2025-09-17</a:t>
            </a:fld>
            <a:endParaRPr lang="en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81081-C203-4E1C-A204-5A6B44C8C6A5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1806245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4A37E18-519D-46E0-89FC-8D2AF5658953}" type="datetimeFigureOut">
              <a:rPr lang="en-SE" smtClean="0"/>
              <a:t>2025-09-17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E481081-C203-4E1C-A204-5A6B44C8C6A5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8402846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microsoft.com/office/2007/relationships/hdphoto" Target="../media/hdphoto1.wdp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.png"/><Relationship Id="rId4" Type="http://schemas.openxmlformats.org/officeDocument/2006/relationships/image" Target="../media/image10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>
            <a:extLst>
              <a:ext uri="{FF2B5EF4-FFF2-40B4-BE49-F238E27FC236}">
                <a16:creationId xmlns:a16="http://schemas.microsoft.com/office/drawing/2014/main" id="{7F2DB89D-F608-96B8-7EB0-EBDA565C7397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1393" t="49645" r="10796"/>
          <a:stretch>
            <a:fillRect/>
          </a:stretch>
        </p:blipFill>
        <p:spPr>
          <a:xfrm>
            <a:off x="3125663" y="4530274"/>
            <a:ext cx="2026252" cy="839761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39D5FBC5-B7C0-A616-A12C-7011532616D0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9211" t="47670" r="10948"/>
          <a:stretch>
            <a:fillRect/>
          </a:stretch>
        </p:blipFill>
        <p:spPr>
          <a:xfrm>
            <a:off x="323851" y="4436767"/>
            <a:ext cx="2278380" cy="102677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A9F2ED46-2C8D-ACCE-A0EB-6EF7B3276A8B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5729" t="46726" r="20673"/>
          <a:stretch>
            <a:fillRect/>
          </a:stretch>
        </p:blipFill>
        <p:spPr>
          <a:xfrm>
            <a:off x="3070860" y="1314739"/>
            <a:ext cx="2178801" cy="1177837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552B9A58-1E40-C6EB-231B-5C0CBEE3A235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9438" t="47709" r="9265"/>
          <a:stretch>
            <a:fillRect/>
          </a:stretch>
        </p:blipFill>
        <p:spPr>
          <a:xfrm>
            <a:off x="3070860" y="2836635"/>
            <a:ext cx="2135858" cy="102601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27777E5-AF38-A71D-C483-E87C57D4F400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15354" t="47670" r="8293"/>
          <a:stretch>
            <a:fillRect/>
          </a:stretch>
        </p:blipFill>
        <p:spPr>
          <a:xfrm>
            <a:off x="438151" y="1242350"/>
            <a:ext cx="2178802" cy="102677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5001FE1-A24E-1E75-E593-73034FEA6322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12148" t="47670" r="9213" b="4238"/>
          <a:stretch>
            <a:fillRect/>
          </a:stretch>
        </p:blipFill>
        <p:spPr>
          <a:xfrm>
            <a:off x="441959" y="2836635"/>
            <a:ext cx="2244090" cy="94361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4E1271BF-D87F-681C-D7B1-1B980314AE41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2312" t="54842" r="12240"/>
          <a:stretch>
            <a:fillRect/>
          </a:stretch>
        </p:blipFill>
        <p:spPr>
          <a:xfrm>
            <a:off x="372853" y="6131163"/>
            <a:ext cx="2438399" cy="886042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62EA9B1B-995B-AC8C-A9AB-1319F9550892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rcRect l="7631" t="50000" r="9055" b="4842"/>
          <a:stretch>
            <a:fillRect/>
          </a:stretch>
        </p:blipFill>
        <p:spPr>
          <a:xfrm>
            <a:off x="3099543" y="6131163"/>
            <a:ext cx="2377440" cy="886042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9491D9DC-7610-17C0-DE8F-9754B395D641}"/>
              </a:ext>
            </a:extLst>
          </p:cNvPr>
          <p:cNvSpPr txBox="1"/>
          <p:nvPr/>
        </p:nvSpPr>
        <p:spPr>
          <a:xfrm>
            <a:off x="1835147" y="-36900"/>
            <a:ext cx="2382984" cy="3054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85" b="1" u="sng" dirty="0">
                <a:latin typeface="Arial" panose="020B0604020202020204" pitchFamily="34" charset="0"/>
                <a:cs typeface="Arial" panose="020B0604020202020204" pitchFamily="34" charset="0"/>
              </a:rPr>
              <a:t>Uncropped blots Fig. 4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67F86CC-BF4F-4B8A-55EB-004DE41E6872}"/>
              </a:ext>
            </a:extLst>
          </p:cNvPr>
          <p:cNvSpPr txBox="1"/>
          <p:nvPr/>
        </p:nvSpPr>
        <p:spPr>
          <a:xfrm>
            <a:off x="214296" y="241168"/>
            <a:ext cx="5822734" cy="3053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Note: Membranes were cut at 75 kDa. For bottom membrane, stripping was performed after TREM2 imaging. For actin imaging, CLEC7A band was covered to not interfere with measurement. Lanes 3, 4, 7 and 8 after ladder were not included in this study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B378FE4-8A54-F47D-C1F1-8B631BCDABA4}"/>
              </a:ext>
            </a:extLst>
          </p:cNvPr>
          <p:cNvSpPr txBox="1"/>
          <p:nvPr/>
        </p:nvSpPr>
        <p:spPr>
          <a:xfrm>
            <a:off x="3408152" y="845635"/>
            <a:ext cx="1621711" cy="334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88" b="1" u="sng" dirty="0">
                <a:latin typeface="Arial" panose="020B0604020202020204" pitchFamily="34" charset="0"/>
                <a:cs typeface="Arial" panose="020B0604020202020204" pitchFamily="34" charset="0"/>
              </a:rPr>
              <a:t>Blot from Fig. 4a: TREM2</a:t>
            </a:r>
          </a:p>
          <a:p>
            <a:pPr algn="ctr"/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(chemiluminescent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C74594C-4E5C-BFE6-3496-1BD752BBAD78}"/>
              </a:ext>
            </a:extLst>
          </p:cNvPr>
          <p:cNvSpPr txBox="1"/>
          <p:nvPr/>
        </p:nvSpPr>
        <p:spPr>
          <a:xfrm>
            <a:off x="781266" y="824449"/>
            <a:ext cx="1621711" cy="334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88" b="1" u="sng" dirty="0">
                <a:latin typeface="Arial" panose="020B0604020202020204" pitchFamily="34" charset="0"/>
                <a:cs typeface="Arial" panose="020B0604020202020204" pitchFamily="34" charset="0"/>
              </a:rPr>
              <a:t>Blot from Fig. 4a: TREM2</a:t>
            </a:r>
          </a:p>
          <a:p>
            <a:pPr algn="ctr"/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(colorimetric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87BBB87-E741-CF02-62FD-71D38271E008}"/>
              </a:ext>
            </a:extLst>
          </p:cNvPr>
          <p:cNvSpPr txBox="1"/>
          <p:nvPr/>
        </p:nvSpPr>
        <p:spPr>
          <a:xfrm>
            <a:off x="666966" y="2445856"/>
            <a:ext cx="1621711" cy="334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88" b="1" u="sng" dirty="0">
                <a:latin typeface="Arial" panose="020B0604020202020204" pitchFamily="34" charset="0"/>
                <a:cs typeface="Arial" panose="020B0604020202020204" pitchFamily="34" charset="0"/>
              </a:rPr>
              <a:t>Blot from Fig. 4a: TLR4</a:t>
            </a:r>
          </a:p>
          <a:p>
            <a:pPr algn="ctr"/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(colorimetric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91E49B1-B229-1A55-9C48-6F4BF8B6CC8F}"/>
              </a:ext>
            </a:extLst>
          </p:cNvPr>
          <p:cNvSpPr txBox="1"/>
          <p:nvPr/>
        </p:nvSpPr>
        <p:spPr>
          <a:xfrm>
            <a:off x="3293852" y="2434595"/>
            <a:ext cx="1621711" cy="334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88" b="1" u="sng" dirty="0">
                <a:latin typeface="Arial" panose="020B0604020202020204" pitchFamily="34" charset="0"/>
                <a:cs typeface="Arial" panose="020B0604020202020204" pitchFamily="34" charset="0"/>
              </a:rPr>
              <a:t>Blot from Fig. 4a: TLR4</a:t>
            </a:r>
          </a:p>
          <a:p>
            <a:pPr algn="ctr"/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(chemiluminescent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3B57394-605D-DCA1-C330-21E8FED26705}"/>
              </a:ext>
            </a:extLst>
          </p:cNvPr>
          <p:cNvSpPr txBox="1"/>
          <p:nvPr/>
        </p:nvSpPr>
        <p:spPr>
          <a:xfrm>
            <a:off x="712686" y="3987110"/>
            <a:ext cx="1621711" cy="334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88" b="1" u="sng" dirty="0">
                <a:latin typeface="Arial" panose="020B0604020202020204" pitchFamily="34" charset="0"/>
                <a:cs typeface="Arial" panose="020B0604020202020204" pitchFamily="34" charset="0"/>
              </a:rPr>
              <a:t>Blot from Fig. 4a: CLEC7A</a:t>
            </a:r>
          </a:p>
          <a:p>
            <a:pPr algn="ctr"/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(colorimetric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627C639-5918-1338-CF59-545D698DF37B}"/>
              </a:ext>
            </a:extLst>
          </p:cNvPr>
          <p:cNvSpPr txBox="1"/>
          <p:nvPr/>
        </p:nvSpPr>
        <p:spPr>
          <a:xfrm>
            <a:off x="3339572" y="3975849"/>
            <a:ext cx="1621711" cy="334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88" b="1" u="sng" dirty="0">
                <a:latin typeface="Arial" panose="020B0604020202020204" pitchFamily="34" charset="0"/>
                <a:cs typeface="Arial" panose="020B0604020202020204" pitchFamily="34" charset="0"/>
              </a:rPr>
              <a:t>Blot from Fig. 4a: CLEC7A</a:t>
            </a:r>
          </a:p>
          <a:p>
            <a:pPr algn="ctr"/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(chemiluminescent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47F359B-48F0-BA5F-A793-7603603E5D5E}"/>
              </a:ext>
            </a:extLst>
          </p:cNvPr>
          <p:cNvSpPr txBox="1"/>
          <p:nvPr/>
        </p:nvSpPr>
        <p:spPr>
          <a:xfrm>
            <a:off x="781266" y="5648071"/>
            <a:ext cx="1621711" cy="334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88" b="1" u="sng" dirty="0">
                <a:latin typeface="Arial" panose="020B0604020202020204" pitchFamily="34" charset="0"/>
                <a:cs typeface="Arial" panose="020B0604020202020204" pitchFamily="34" charset="0"/>
              </a:rPr>
              <a:t>Blot from Fig. 4a: Actin</a:t>
            </a:r>
          </a:p>
          <a:p>
            <a:pPr algn="ctr"/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(colorimetric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7700164-1844-B695-4C13-A05264894F16}"/>
              </a:ext>
            </a:extLst>
          </p:cNvPr>
          <p:cNvSpPr txBox="1"/>
          <p:nvPr/>
        </p:nvSpPr>
        <p:spPr>
          <a:xfrm>
            <a:off x="3408152" y="5636810"/>
            <a:ext cx="1621711" cy="334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88" b="1" u="sng" dirty="0">
                <a:latin typeface="Arial" panose="020B0604020202020204" pitchFamily="34" charset="0"/>
                <a:cs typeface="Arial" panose="020B0604020202020204" pitchFamily="34" charset="0"/>
              </a:rPr>
              <a:t>Blot from Fig. 4a: Actin</a:t>
            </a:r>
          </a:p>
          <a:p>
            <a:pPr algn="ctr"/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(chemiluminescent)</a:t>
            </a:r>
          </a:p>
        </p:txBody>
      </p:sp>
    </p:spTree>
    <p:extLst>
      <p:ext uri="{BB962C8B-B14F-4D97-AF65-F5344CB8AC3E}">
        <p14:creationId xmlns:p14="http://schemas.microsoft.com/office/powerpoint/2010/main" val="10365587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6">
            <a:extLst>
              <a:ext uri="{FF2B5EF4-FFF2-40B4-BE49-F238E27FC236}">
                <a16:creationId xmlns:a16="http://schemas.microsoft.com/office/drawing/2014/main" id="{382EDB50-6AC3-ECBA-C3D0-F6D261923AA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16" t="-3174" r="18643" b="-655"/>
          <a:stretch/>
        </p:blipFill>
        <p:spPr>
          <a:xfrm rot="10800000" flipH="1">
            <a:off x="1201323" y="1184811"/>
            <a:ext cx="1674300" cy="1535564"/>
          </a:xfrm>
          <a:prstGeom prst="rect">
            <a:avLst/>
          </a:prstGeom>
        </p:spPr>
      </p:pic>
      <p:pic>
        <p:nvPicPr>
          <p:cNvPr id="5" name="Imagen 4">
            <a:extLst>
              <a:ext uri="{FF2B5EF4-FFF2-40B4-BE49-F238E27FC236}">
                <a16:creationId xmlns:a16="http://schemas.microsoft.com/office/drawing/2014/main" id="{CF6054DB-756F-62ED-D185-7AC9CFB68F4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21" t="16200" r="23438" b="207"/>
          <a:stretch/>
        </p:blipFill>
        <p:spPr>
          <a:xfrm rot="10800000" flipH="1">
            <a:off x="1250561" y="2999546"/>
            <a:ext cx="1591179" cy="117465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A011DCC-1723-0DA6-2745-3965673E14E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flipV="1">
            <a:off x="3255665" y="1306348"/>
            <a:ext cx="1975593" cy="135838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77A93EF-14FC-9B98-831E-C999D108C1F8}"/>
              </a:ext>
            </a:extLst>
          </p:cNvPr>
          <p:cNvSpPr txBox="1"/>
          <p:nvPr/>
        </p:nvSpPr>
        <p:spPr>
          <a:xfrm>
            <a:off x="1634049" y="351162"/>
            <a:ext cx="3170775" cy="3054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85" b="1" u="sng" dirty="0">
                <a:latin typeface="Arial" panose="020B0604020202020204" pitchFamily="34" charset="0"/>
                <a:cs typeface="Arial" panose="020B0604020202020204" pitchFamily="34" charset="0"/>
              </a:rPr>
              <a:t>Uncropped blots Suppl. Fig. 1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07F5FE8-2A28-C63A-94BE-86FCEA420F40}"/>
              </a:ext>
            </a:extLst>
          </p:cNvPr>
          <p:cNvSpPr txBox="1"/>
          <p:nvPr/>
        </p:nvSpPr>
        <p:spPr>
          <a:xfrm>
            <a:off x="1477112" y="965316"/>
            <a:ext cx="1122723" cy="260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46" b="1" u="sng" dirty="0">
                <a:latin typeface="Arial" panose="020B0604020202020204" pitchFamily="34" charset="0"/>
                <a:cs typeface="Arial" panose="020B0604020202020204" pitchFamily="34" charset="0"/>
              </a:rPr>
              <a:t>Galectin-3</a:t>
            </a:r>
          </a:p>
          <a:p>
            <a:pPr algn="ctr"/>
            <a:r>
              <a:rPr lang="en-US" sz="546" dirty="0">
                <a:latin typeface="Arial" panose="020B0604020202020204" pitchFamily="34" charset="0"/>
                <a:cs typeface="Arial" panose="020B0604020202020204" pitchFamily="34" charset="0"/>
              </a:rPr>
              <a:t>(chemiluminescent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9D95D3D-1806-DFD0-9E52-BFECFC004191}"/>
              </a:ext>
            </a:extLst>
          </p:cNvPr>
          <p:cNvSpPr txBox="1"/>
          <p:nvPr/>
        </p:nvSpPr>
        <p:spPr>
          <a:xfrm>
            <a:off x="1477112" y="2767734"/>
            <a:ext cx="1122723" cy="260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46" b="1" u="sng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  <a:p>
            <a:pPr algn="ctr"/>
            <a:r>
              <a:rPr lang="en-US" sz="546" dirty="0">
                <a:latin typeface="Arial" panose="020B0604020202020204" pitchFamily="34" charset="0"/>
                <a:cs typeface="Arial" panose="020B0604020202020204" pitchFamily="34" charset="0"/>
              </a:rPr>
              <a:t>(chemiluminescent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E4E60E1-D7B6-37EC-0B77-585DE09E8589}"/>
              </a:ext>
            </a:extLst>
          </p:cNvPr>
          <p:cNvSpPr txBox="1"/>
          <p:nvPr/>
        </p:nvSpPr>
        <p:spPr>
          <a:xfrm>
            <a:off x="3659241" y="990082"/>
            <a:ext cx="1122723" cy="176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46" dirty="0">
                <a:latin typeface="Arial" panose="020B0604020202020204" pitchFamily="34" charset="0"/>
                <a:cs typeface="Arial" panose="020B0604020202020204" pitchFamily="34" charset="0"/>
              </a:rPr>
              <a:t>Colorimetri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A143046-315B-85F1-9B83-444B53ECB2CD}"/>
              </a:ext>
            </a:extLst>
          </p:cNvPr>
          <p:cNvSpPr txBox="1"/>
          <p:nvPr/>
        </p:nvSpPr>
        <p:spPr>
          <a:xfrm>
            <a:off x="1378185" y="680309"/>
            <a:ext cx="3426639" cy="1988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92" dirty="0">
                <a:latin typeface="Arial" panose="020B0604020202020204" pitchFamily="34" charset="0"/>
                <a:cs typeface="Arial" panose="020B0604020202020204" pitchFamily="34" charset="0"/>
              </a:rPr>
              <a:t>Note: Stripping not performed in these blots, just covered the Galectin-3 band</a:t>
            </a:r>
          </a:p>
        </p:txBody>
      </p:sp>
    </p:spTree>
    <p:extLst>
      <p:ext uri="{BB962C8B-B14F-4D97-AF65-F5344CB8AC3E}">
        <p14:creationId xmlns:p14="http://schemas.microsoft.com/office/powerpoint/2010/main" val="15778992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</TotalTime>
  <Words>166</Words>
  <Application>Microsoft Office PowerPoint</Application>
  <PresentationFormat>A4 Paper (210x297 mm)</PresentationFormat>
  <Paragraphs>26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luís Camprubí Ferrer</dc:creator>
  <cp:lastModifiedBy>Lluís Camprubí Ferrer</cp:lastModifiedBy>
  <cp:revision>1</cp:revision>
  <dcterms:created xsi:type="dcterms:W3CDTF">2025-09-17T14:41:29Z</dcterms:created>
  <dcterms:modified xsi:type="dcterms:W3CDTF">2025-09-17T15:10:03Z</dcterms:modified>
</cp:coreProperties>
</file>